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9" r:id="rId2"/>
    <p:sldId id="436" r:id="rId3"/>
    <p:sldId id="437" r:id="rId4"/>
    <p:sldId id="43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477"/>
    <p:restoredTop sz="96327"/>
  </p:normalViewPr>
  <p:slideViewPr>
    <p:cSldViewPr snapToGrid="0">
      <p:cViewPr>
        <p:scale>
          <a:sx n="187" d="100"/>
          <a:sy n="187" d="100"/>
        </p:scale>
        <p:origin x="14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217C37-F1D7-2946-96C6-E633A7FB8A5F}" type="datetimeFigureOut">
              <a:rPr lang="en-US" smtClean="0"/>
              <a:t>5/8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51EFFD-625C-0C45-88F7-337AE86C5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0050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7AF3C73-46A9-D548-B382-F2EAEEDFE7FB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1795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7AF3C73-46A9-D548-B382-F2EAEEDFE7FB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8012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9D3489-9C80-486E-041E-E3B4962D10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227E07F-CF41-BC8D-0A52-37FD8F8170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03AD24-E3E0-EA3C-9475-73CFA7558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986E2-B0B3-F54F-83B9-E934956BEA2A}" type="datetimeFigureOut">
              <a:rPr lang="en-US" smtClean="0"/>
              <a:t>5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70F9AB-3796-1511-E313-C59E2D62C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588129-CC98-FA29-DDC4-89ACB87982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7AC0B-2C1B-A047-81F4-98B0963C2C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536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CAE247-18BF-60CB-C5B3-0631113135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CC36C9-8060-8180-96B3-CE4ECD0E84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2A4AA8-9765-BCE9-18A7-75B8D507C4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986E2-B0B3-F54F-83B9-E934956BEA2A}" type="datetimeFigureOut">
              <a:rPr lang="en-US" smtClean="0"/>
              <a:t>5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D7C83D-5727-B004-CDE8-7A25846212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1B99D3-486C-7358-3E1E-73508B95B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7AC0B-2C1B-A047-81F4-98B0963C2C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1324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C3ECD88-CF70-5FEF-135C-2856F8C04B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8F0291-2465-95B4-5578-E2F0AC01FA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A0DB48-3EE7-7C2C-FEE6-3AC3A027E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986E2-B0B3-F54F-83B9-E934956BEA2A}" type="datetimeFigureOut">
              <a:rPr lang="en-US" smtClean="0"/>
              <a:t>5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299D8E-D511-A292-EDA4-A611F5658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0DCD1E-5305-4466-951E-664E326BC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7AC0B-2C1B-A047-81F4-98B0963C2C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464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AE7DD3-439B-35CC-8398-5098F1D3F3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040723-3456-BF84-EC18-917D5753C2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1F308F-2E5F-3F66-3569-3397F3932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986E2-B0B3-F54F-83B9-E934956BEA2A}" type="datetimeFigureOut">
              <a:rPr lang="en-US" smtClean="0"/>
              <a:t>5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30EA23-768A-8ECA-7F35-C8B5B4556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65B216-92AB-AC7F-507B-2F3708541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7AC0B-2C1B-A047-81F4-98B0963C2C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984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E98158-12F1-6CBD-7530-9DCDED3E23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C017BA-44DC-99E7-A4D4-2F5B9A2A12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7F1CDC-2E03-BA6D-367C-E2A7D59376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986E2-B0B3-F54F-83B9-E934956BEA2A}" type="datetimeFigureOut">
              <a:rPr lang="en-US" smtClean="0"/>
              <a:t>5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8B7E7A-BF6B-A0C2-F871-3087B935C9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01D28A-720D-37DF-A060-B0DB35211E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7AC0B-2C1B-A047-81F4-98B0963C2C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460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B15E1F-5AC2-3A01-2556-E59E6DA07E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FA7BDC-1670-F725-DACC-DEC9B7D7DC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1EC224-1F45-7533-27AC-5DBCDCD695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0CC4DB-6128-2F8C-66BC-C8130C0BE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986E2-B0B3-F54F-83B9-E934956BEA2A}" type="datetimeFigureOut">
              <a:rPr lang="en-US" smtClean="0"/>
              <a:t>5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8CC1B6-EDC5-CAAB-7E45-A9FBABE75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309E7D-5763-D81A-080B-316D98541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7AC0B-2C1B-A047-81F4-98B0963C2C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478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335B53-1244-804A-A04F-E417BB7E9E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B6B65F-C16F-DE4F-3C47-7540D878A2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8B1CFD-5D84-6A03-E0D3-5ADF5453F9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978116D-448B-5ACC-83F1-118275B2727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CE0E39B-7542-572E-901F-BE786ECD5B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81CD4E6-BCB2-90A0-2F2F-D7ED1CDCCA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986E2-B0B3-F54F-83B9-E934956BEA2A}" type="datetimeFigureOut">
              <a:rPr lang="en-US" smtClean="0"/>
              <a:t>5/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C9DE3CD-B66C-A40F-40FA-406FB90A2A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284FE49-86FD-E7FE-FE91-6FF5D401F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7AC0B-2C1B-A047-81F4-98B0963C2C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042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406FC0-119A-903B-6DAD-37788120FF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BD74971-A389-8691-F5F4-F8E0EC4866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986E2-B0B3-F54F-83B9-E934956BEA2A}" type="datetimeFigureOut">
              <a:rPr lang="en-US" smtClean="0"/>
              <a:t>5/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AC8AEA-16E0-ACE6-45EB-8CC17E76A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FD27EE4-20D0-D7F3-9C1C-ECF2BB079E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7AC0B-2C1B-A047-81F4-98B0963C2C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515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8CAF327-E122-6F1B-D402-F8633272F2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986E2-B0B3-F54F-83B9-E934956BEA2A}" type="datetimeFigureOut">
              <a:rPr lang="en-US" smtClean="0"/>
              <a:t>5/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CE16ABA-B5B6-7300-89F1-C2D8608097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3F73C9-323D-B1C8-0C73-0101918112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7AC0B-2C1B-A047-81F4-98B0963C2C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006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13E8F-B710-F496-3F61-30F91EFA97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AC885C-D9DF-E645-B9A9-A756D72E70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AF0BB1-0954-69EF-F9D3-92A8C84EDD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C11B2F-4B46-3C25-461F-C67CE71A1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986E2-B0B3-F54F-83B9-E934956BEA2A}" type="datetimeFigureOut">
              <a:rPr lang="en-US" smtClean="0"/>
              <a:t>5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E60E0B-97C3-C66D-F914-3F39CF8F3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8C8D98-F04A-4681-47F1-DB3F5848E3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7AC0B-2C1B-A047-81F4-98B0963C2C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038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20506A-396A-283F-A4D2-FD2B7F6B70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66207C-14F3-4376-49DF-98E70CDE0A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F09039-5D80-3037-27D0-171BA28988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DFEAE5-E5DC-A5BF-DB75-761FCAA1F7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986E2-B0B3-F54F-83B9-E934956BEA2A}" type="datetimeFigureOut">
              <a:rPr lang="en-US" smtClean="0"/>
              <a:t>5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8B9905-80D1-BE0F-87C6-E8C5E3EE9A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41AEC8-BE8C-9A0C-12DC-CB68B53783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7AC0B-2C1B-A047-81F4-98B0963C2C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933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97EF176-0880-6E8C-613E-AC723CEA20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15EC7B-DB5B-C2DC-E292-606EEFC884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026764-6BF6-9366-07A2-5C164EC795D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B986E2-B0B3-F54F-83B9-E934956BEA2A}" type="datetimeFigureOut">
              <a:rPr lang="en-US" smtClean="0"/>
              <a:t>5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BE59D3-859F-547C-A54D-D612C110F8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FAEB8B-1E75-F878-E5C1-312188D853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07AC0B-2C1B-A047-81F4-98B0963C2C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990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11" Type="http://schemas.openxmlformats.org/officeDocument/2006/relationships/image" Target="../media/image11.png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0E0C1776-8435-3011-1AFA-90047ECF622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803" r="4894" b="29181"/>
          <a:stretch/>
        </p:blipFill>
        <p:spPr>
          <a:xfrm>
            <a:off x="220719" y="694967"/>
            <a:ext cx="5382951" cy="269460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8A20D65-2E50-45BB-02F3-9402D449C7B2}"/>
              </a:ext>
            </a:extLst>
          </p:cNvPr>
          <p:cNvSpPr txBox="1"/>
          <p:nvPr/>
        </p:nvSpPr>
        <p:spPr>
          <a:xfrm>
            <a:off x="220719" y="3705656"/>
            <a:ext cx="1023449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: Impact of low or high CACNA1D expression  on disease free and overall survival in BC. </a:t>
            </a:r>
            <a:r>
              <a:rPr lang="en-US" dirty="0" err="1"/>
              <a:t>Cbiportal</a:t>
            </a:r>
            <a:r>
              <a:rPr lang="en-US" dirty="0"/>
              <a:t> analysis of TCGA BC database with groups split by median into high or low CACNA1D for (A) disease free survival (p-value 0.0127, q-value 0.0254) across all BC subtypes and (B) Overall survival in TNBC.</a:t>
            </a:r>
          </a:p>
        </p:txBody>
      </p:sp>
      <p:pic>
        <p:nvPicPr>
          <p:cNvPr id="5" name="Picture 4" descr="A graph of a number&#10;&#10;Description automatically generated with medium confidence">
            <a:extLst>
              <a:ext uri="{FF2B5EF4-FFF2-40B4-BE49-F238E27FC236}">
                <a16:creationId xmlns:a16="http://schemas.microsoft.com/office/drawing/2014/main" id="{A5F7EF08-B248-8272-010D-BF96DCFA002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167" r="4981" b="28327"/>
          <a:stretch/>
        </p:blipFill>
        <p:spPr>
          <a:xfrm>
            <a:off x="5830326" y="701900"/>
            <a:ext cx="5355458" cy="27271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AC77C18-9539-C457-3685-1AF64900D1E2}"/>
              </a:ext>
            </a:extLst>
          </p:cNvPr>
          <p:cNvSpPr txBox="1"/>
          <p:nvPr/>
        </p:nvSpPr>
        <p:spPr>
          <a:xfrm>
            <a:off x="3582159" y="1188224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igh CACNA1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D092BE4-492F-E8AD-D8B3-24103995E759}"/>
              </a:ext>
            </a:extLst>
          </p:cNvPr>
          <p:cNvSpPr txBox="1"/>
          <p:nvPr/>
        </p:nvSpPr>
        <p:spPr>
          <a:xfrm>
            <a:off x="3606203" y="902614"/>
            <a:ext cx="8595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Low CACNA1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E2329E-B68D-642C-51C4-5B7F0B8FA029}"/>
              </a:ext>
            </a:extLst>
          </p:cNvPr>
          <p:cNvSpPr txBox="1"/>
          <p:nvPr/>
        </p:nvSpPr>
        <p:spPr>
          <a:xfrm>
            <a:off x="9115513" y="1188224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igh CACNA1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6A5DCAA-F491-811F-298F-5FC2A2F85176}"/>
              </a:ext>
            </a:extLst>
          </p:cNvPr>
          <p:cNvSpPr txBox="1"/>
          <p:nvPr/>
        </p:nvSpPr>
        <p:spPr>
          <a:xfrm>
            <a:off x="9139557" y="902614"/>
            <a:ext cx="8595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Low CACNA1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5E8A4DC-C730-9704-20E4-EE0508E1962E}"/>
              </a:ext>
            </a:extLst>
          </p:cNvPr>
          <p:cNvSpPr txBox="1"/>
          <p:nvPr/>
        </p:nvSpPr>
        <p:spPr>
          <a:xfrm>
            <a:off x="129396" y="5172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8568326-67F1-308D-9EFC-83276D211695}"/>
              </a:ext>
            </a:extLst>
          </p:cNvPr>
          <p:cNvSpPr txBox="1"/>
          <p:nvPr/>
        </p:nvSpPr>
        <p:spPr>
          <a:xfrm>
            <a:off x="5720444" y="53328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67983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>
            <a:extLst>
              <a:ext uri="{FF2B5EF4-FFF2-40B4-BE49-F238E27FC236}">
                <a16:creationId xmlns:a16="http://schemas.microsoft.com/office/drawing/2014/main" id="{919FE762-D79C-B112-E72B-2547D79D04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21908" y="3119333"/>
            <a:ext cx="810130" cy="105899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E4CD913-9E6C-BD1D-F802-E0B1C4E1A36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2494" y="4340551"/>
            <a:ext cx="2240178" cy="156405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1FC8AA46-3E9B-0C72-E03E-6C1FF12423D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42026" y="3126995"/>
            <a:ext cx="810130" cy="105899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B5ACA92-CB87-93E1-2D72-D83B8BB88B5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5842" y="2655991"/>
            <a:ext cx="2240178" cy="1564052"/>
          </a:xfrm>
          <a:prstGeom prst="rect">
            <a:avLst/>
          </a:prstGeom>
        </p:spPr>
      </p:pic>
      <p:sp>
        <p:nvSpPr>
          <p:cNvPr id="85" name="TextBox 84"/>
          <p:cNvSpPr txBox="1"/>
          <p:nvPr/>
        </p:nvSpPr>
        <p:spPr>
          <a:xfrm>
            <a:off x="316544" y="6061047"/>
            <a:ext cx="4762244" cy="782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641" b="1" i="1" dirty="0">
                <a:latin typeface="Arial" panose="020B0604020202020204" pitchFamily="34" charset="0"/>
                <a:cs typeface="Arial" panose="020B0604020202020204" pitchFamily="34" charset="0"/>
              </a:rPr>
              <a:t>Figure S2:</a:t>
            </a:r>
            <a:r>
              <a:rPr lang="en-IE" sz="641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ffect of COTI-2 treatment on calcium channel expression and SOCE in missense TP53 mutant TNBC cell lines. </a:t>
            </a:r>
            <a:r>
              <a:rPr lang="en-IE" sz="641" b="1" i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IE" sz="641" i="1" dirty="0">
                <a:latin typeface="Arial" panose="020B0604020202020204" pitchFamily="34" charset="0"/>
                <a:cs typeface="Arial" panose="020B0604020202020204" pitchFamily="34" charset="0"/>
              </a:rPr>
              <a:t>Effect of COTI-2 treatment on relative fold change gene expression of calcium channels (</a:t>
            </a:r>
            <a:r>
              <a:rPr lang="en-IE" sz="641" i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IE" sz="641" i="1" dirty="0">
                <a:latin typeface="Arial" panose="020B0604020202020204" pitchFamily="34" charset="0"/>
                <a:cs typeface="Arial" panose="020B0604020202020204" pitchFamily="34" charset="0"/>
              </a:rPr>
              <a:t>)TRPC6, (ii) TRPM4, (iii) Cav1.3 (CACNA1D) using </a:t>
            </a:r>
            <a:r>
              <a:rPr lang="en-IE" sz="641" i="1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IE" sz="641" i="1" dirty="0">
                <a:latin typeface="Arial" panose="020B0604020202020204" pitchFamily="34" charset="0"/>
                <a:cs typeface="Arial" panose="020B0604020202020204" pitchFamily="34" charset="0"/>
              </a:rPr>
              <a:t>-PCR in MFM-223 cells (purple) and MDA-MB-468 cells compared to untreated control. The impact of COTI-2 treatment on store operated calcium in </a:t>
            </a:r>
            <a:r>
              <a:rPr lang="en-IE" sz="641" b="1" i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IE" sz="641" i="1" dirty="0">
                <a:latin typeface="Arial" panose="020B0604020202020204" pitchFamily="34" charset="0"/>
                <a:cs typeface="Arial" panose="020B0604020202020204" pitchFamily="34" charset="0"/>
              </a:rPr>
              <a:t>MFM-223 (N=6, n=12) vs DMSO (N=5, n=10) and </a:t>
            </a:r>
            <a:r>
              <a:rPr lang="en-IE" sz="641" b="1" i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IE" sz="641" i="1" dirty="0">
                <a:latin typeface="Arial" panose="020B0604020202020204" pitchFamily="34" charset="0"/>
                <a:cs typeface="Arial" panose="020B0604020202020204" pitchFamily="34" charset="0"/>
              </a:rPr>
              <a:t>MDA-MB-456 (N=6, n10) vs DMSO (N=6, n=12) control was measured by (</a:t>
            </a:r>
            <a:r>
              <a:rPr lang="en-IE" sz="641" i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IE" sz="641" i="1" dirty="0">
                <a:latin typeface="Arial" panose="020B0604020202020204" pitchFamily="34" charset="0"/>
                <a:cs typeface="Arial" panose="020B0604020202020204" pitchFamily="34" charset="0"/>
              </a:rPr>
              <a:t>) Fura-2AM </a:t>
            </a:r>
            <a:r>
              <a:rPr lang="en-IE" sz="641" i="1" dirty="0" err="1">
                <a:latin typeface="Arial" panose="020B0604020202020204" pitchFamily="34" charset="0"/>
                <a:cs typeface="Arial" panose="020B0604020202020204" pitchFamily="34" charset="0"/>
              </a:rPr>
              <a:t>ratiometeric</a:t>
            </a:r>
            <a:r>
              <a:rPr lang="en-IE" sz="641" i="1" dirty="0">
                <a:latin typeface="Arial" panose="020B0604020202020204" pitchFamily="34" charset="0"/>
                <a:cs typeface="Arial" panose="020B0604020202020204" pitchFamily="34" charset="0"/>
              </a:rPr>
              <a:t> trace over time(s), from which (ii) average baseline 0mM calcium, (iii) max TG peak and (iv) max calcium entry peak was calculated. Mann-Whitney was used for all above comparing two groups. *p&lt;0.05, **p&lt;0.01, ***p&lt;0.001, ****p&lt;0.0001. 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08003974-2BB7-2042-9210-A150AD41BAE8}"/>
              </a:ext>
            </a:extLst>
          </p:cNvPr>
          <p:cNvSpPr/>
          <p:nvPr/>
        </p:nvSpPr>
        <p:spPr>
          <a:xfrm>
            <a:off x="2323899" y="267184"/>
            <a:ext cx="154617" cy="817074"/>
          </a:xfrm>
          <a:prstGeom prst="rect">
            <a:avLst/>
          </a:prstGeom>
          <a:noFill/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6"/>
          </a:p>
        </p:txBody>
      </p:sp>
      <p:sp>
        <p:nvSpPr>
          <p:cNvPr id="156" name="Rectangle 155"/>
          <p:cNvSpPr/>
          <p:nvPr/>
        </p:nvSpPr>
        <p:spPr>
          <a:xfrm flipH="1">
            <a:off x="2359944" y="198365"/>
            <a:ext cx="93125" cy="9469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6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07FAF00-7BCD-394A-B679-E17752B84F59}"/>
              </a:ext>
            </a:extLst>
          </p:cNvPr>
          <p:cNvSpPr/>
          <p:nvPr/>
        </p:nvSpPr>
        <p:spPr>
          <a:xfrm>
            <a:off x="2364339" y="267183"/>
            <a:ext cx="93125" cy="85828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6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597CE5E-AD2C-113D-63C7-6E390DD3C770}"/>
              </a:ext>
            </a:extLst>
          </p:cNvPr>
          <p:cNvSpPr txBox="1"/>
          <p:nvPr/>
        </p:nvSpPr>
        <p:spPr>
          <a:xfrm>
            <a:off x="341929" y="272413"/>
            <a:ext cx="150600" cy="210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0" b="1" i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9AD556F-1F2A-71B6-5F9F-E6575C989504}"/>
              </a:ext>
            </a:extLst>
          </p:cNvPr>
          <p:cNvSpPr txBox="1"/>
          <p:nvPr/>
        </p:nvSpPr>
        <p:spPr>
          <a:xfrm>
            <a:off x="2593323" y="4622667"/>
            <a:ext cx="178117" cy="32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0" b="1" i="1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34FC26C-691A-98F3-6E8E-199ABF3D5F59}"/>
              </a:ext>
            </a:extLst>
          </p:cNvPr>
          <p:cNvSpPr txBox="1"/>
          <p:nvPr/>
        </p:nvSpPr>
        <p:spPr>
          <a:xfrm>
            <a:off x="3407780" y="4613487"/>
            <a:ext cx="200011" cy="4478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0" b="1" i="1" dirty="0"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7F491ED-059F-444E-D6B2-7A7C2F81B299}"/>
              </a:ext>
            </a:extLst>
          </p:cNvPr>
          <p:cNvSpPr txBox="1"/>
          <p:nvPr/>
        </p:nvSpPr>
        <p:spPr>
          <a:xfrm>
            <a:off x="4259394" y="4606993"/>
            <a:ext cx="229540" cy="32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0" b="1" i="1" dirty="0">
                <a:latin typeface="Arial" panose="020B0604020202020204" pitchFamily="34" charset="0"/>
                <a:cs typeface="Arial" panose="020B0604020202020204" pitchFamily="34" charset="0"/>
              </a:rPr>
              <a:t>iv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8BA8556-5BFA-FEFA-304B-42ACF470C0FF}"/>
              </a:ext>
            </a:extLst>
          </p:cNvPr>
          <p:cNvSpPr txBox="1"/>
          <p:nvPr/>
        </p:nvSpPr>
        <p:spPr>
          <a:xfrm>
            <a:off x="320829" y="4249020"/>
            <a:ext cx="150600" cy="210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0" b="1" i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250BB44-13CA-72EF-AEA1-BC83D94EC28C}"/>
              </a:ext>
            </a:extLst>
          </p:cNvPr>
          <p:cNvSpPr txBox="1"/>
          <p:nvPr/>
        </p:nvSpPr>
        <p:spPr>
          <a:xfrm>
            <a:off x="455374" y="4243779"/>
            <a:ext cx="178117" cy="210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0" b="1" i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77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BF5FD61-E1D1-D963-9010-10C4775025FB}"/>
              </a:ext>
            </a:extLst>
          </p:cNvPr>
          <p:cNvSpPr txBox="1"/>
          <p:nvPr/>
        </p:nvSpPr>
        <p:spPr>
          <a:xfrm>
            <a:off x="2598076" y="3031748"/>
            <a:ext cx="178117" cy="32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0" b="1" i="1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704A448-9C52-8698-1EAC-331BC8D5660F}"/>
              </a:ext>
            </a:extLst>
          </p:cNvPr>
          <p:cNvSpPr txBox="1"/>
          <p:nvPr/>
        </p:nvSpPr>
        <p:spPr>
          <a:xfrm>
            <a:off x="3388497" y="3022568"/>
            <a:ext cx="200011" cy="4478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0" b="1" i="1" dirty="0"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91F2E27-4B1A-2189-CB44-39D946731B73}"/>
              </a:ext>
            </a:extLst>
          </p:cNvPr>
          <p:cNvSpPr txBox="1"/>
          <p:nvPr/>
        </p:nvSpPr>
        <p:spPr>
          <a:xfrm>
            <a:off x="4244918" y="3030497"/>
            <a:ext cx="229540" cy="32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0" b="1" i="1" dirty="0">
                <a:latin typeface="Arial" panose="020B0604020202020204" pitchFamily="34" charset="0"/>
                <a:cs typeface="Arial" panose="020B0604020202020204" pitchFamily="34" charset="0"/>
              </a:rPr>
              <a:t>iv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76252B8-5C32-C67B-8DC3-49452746EA41}"/>
              </a:ext>
            </a:extLst>
          </p:cNvPr>
          <p:cNvSpPr txBox="1"/>
          <p:nvPr/>
        </p:nvSpPr>
        <p:spPr>
          <a:xfrm>
            <a:off x="407540" y="2577658"/>
            <a:ext cx="178117" cy="210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0" b="1" i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77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F4C3642-16A8-37DA-92C8-2E428E027157}"/>
              </a:ext>
            </a:extLst>
          </p:cNvPr>
          <p:cNvSpPr txBox="1"/>
          <p:nvPr/>
        </p:nvSpPr>
        <p:spPr>
          <a:xfrm>
            <a:off x="290571" y="2584995"/>
            <a:ext cx="150600" cy="210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0" b="1" i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A27B467C-1ABC-D910-270C-775BCE7ED62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99003" y="4769931"/>
            <a:ext cx="810130" cy="1058993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7EADB5AE-FD5A-B13C-BF6B-6C368764F8B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321608" y="4754290"/>
            <a:ext cx="757180" cy="1058993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098AC11A-E2A5-CD8F-16D5-CE7F9D8DCAC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68658" y="3160936"/>
            <a:ext cx="810130" cy="1058993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9F242E49-3196-DAC5-4F0E-97382E2E514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529768" y="4769931"/>
            <a:ext cx="810130" cy="1058993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BABB7145-7E54-B9A3-5107-058DB993F0D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50747" y="323475"/>
            <a:ext cx="3296343" cy="225357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5FF9E58-4092-8C6A-17A5-314608D93988}"/>
              </a:ext>
            </a:extLst>
          </p:cNvPr>
          <p:cNvSpPr txBox="1"/>
          <p:nvPr/>
        </p:nvSpPr>
        <p:spPr>
          <a:xfrm>
            <a:off x="802943" y="567075"/>
            <a:ext cx="152381" cy="20095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6" dirty="0" err="1"/>
              <a:t>i</a:t>
            </a:r>
            <a:endParaRPr lang="en-US" sz="706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4DBF73-61D0-2311-EC44-36AA61A4B430}"/>
              </a:ext>
            </a:extLst>
          </p:cNvPr>
          <p:cNvSpPr txBox="1"/>
          <p:nvPr/>
        </p:nvSpPr>
        <p:spPr>
          <a:xfrm>
            <a:off x="1782140" y="557927"/>
            <a:ext cx="161639" cy="30957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6" dirty="0"/>
              <a:t>ii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04764F6-A82A-5454-E76E-1D9CF6C1600F}"/>
              </a:ext>
            </a:extLst>
          </p:cNvPr>
          <p:cNvSpPr txBox="1"/>
          <p:nvPr/>
        </p:nvSpPr>
        <p:spPr>
          <a:xfrm>
            <a:off x="2777943" y="557927"/>
            <a:ext cx="184731" cy="41819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706" dirty="0"/>
              <a:t>ii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BE3C34A-8FB8-5D1E-5273-CE33EA57CDF8}"/>
              </a:ext>
            </a:extLst>
          </p:cNvPr>
          <p:cNvSpPr txBox="1"/>
          <p:nvPr/>
        </p:nvSpPr>
        <p:spPr>
          <a:xfrm>
            <a:off x="802943" y="1703513"/>
            <a:ext cx="152381" cy="20095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6" dirty="0" err="1"/>
              <a:t>i</a:t>
            </a:r>
            <a:endParaRPr lang="en-US" sz="706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92B8B67-F175-86E9-911C-F6AD06ECC6BE}"/>
              </a:ext>
            </a:extLst>
          </p:cNvPr>
          <p:cNvSpPr txBox="1"/>
          <p:nvPr/>
        </p:nvSpPr>
        <p:spPr>
          <a:xfrm>
            <a:off x="1782140" y="1699172"/>
            <a:ext cx="161639" cy="30957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6" dirty="0"/>
              <a:t>ii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3C49292-DB60-199B-C28A-6552354F582D}"/>
              </a:ext>
            </a:extLst>
          </p:cNvPr>
          <p:cNvSpPr txBox="1"/>
          <p:nvPr/>
        </p:nvSpPr>
        <p:spPr>
          <a:xfrm>
            <a:off x="2777943" y="1694365"/>
            <a:ext cx="184731" cy="41819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706" dirty="0"/>
              <a:t>iii</a:t>
            </a:r>
          </a:p>
        </p:txBody>
      </p:sp>
    </p:spTree>
    <p:extLst>
      <p:ext uri="{BB962C8B-B14F-4D97-AF65-F5344CB8AC3E}">
        <p14:creationId xmlns:p14="http://schemas.microsoft.com/office/powerpoint/2010/main" val="29591628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21">
            <a:extLst>
              <a:ext uri="{FF2B5EF4-FFF2-40B4-BE49-F238E27FC236}">
                <a16:creationId xmlns:a16="http://schemas.microsoft.com/office/drawing/2014/main" id="{08003974-2BB7-2042-9210-A150AD41BAE8}"/>
              </a:ext>
            </a:extLst>
          </p:cNvPr>
          <p:cNvSpPr/>
          <p:nvPr/>
        </p:nvSpPr>
        <p:spPr>
          <a:xfrm>
            <a:off x="2323899" y="-57281"/>
            <a:ext cx="154617" cy="817074"/>
          </a:xfrm>
          <a:prstGeom prst="rect">
            <a:avLst/>
          </a:prstGeom>
          <a:noFill/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6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AC1E6CC-F324-E0DD-0057-5D4BEEBEC5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6171" y="279759"/>
            <a:ext cx="1485900" cy="212407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D3613C2-8313-D22E-CF7F-17CB63204474}"/>
              </a:ext>
            </a:extLst>
          </p:cNvPr>
          <p:cNvSpPr txBox="1"/>
          <p:nvPr/>
        </p:nvSpPr>
        <p:spPr>
          <a:xfrm>
            <a:off x="90164" y="2466215"/>
            <a:ext cx="434535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E" sz="1200" b="1" i="1" dirty="0">
                <a:effectLst/>
                <a:latin typeface="Arial" panose="020B0604020202020204" pitchFamily="34" charset="0"/>
              </a:rPr>
              <a:t>Figure S3: CACNA1D expression after siRNA knockdown. </a:t>
            </a:r>
            <a:r>
              <a:rPr lang="en-IE" sz="1200" i="1" dirty="0">
                <a:effectLst/>
                <a:latin typeface="Arial" panose="020B0604020202020204" pitchFamily="34" charset="0"/>
              </a:rPr>
              <a:t>CACNA1D fold change gene expression in CAL-51 after siRNA knockdown for 48h. </a:t>
            </a:r>
            <a:endParaRPr lang="en-IE" sz="1200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8247455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1F083F3-C5F4-64E7-8ED5-3812EB766B0C}"/>
              </a:ext>
            </a:extLst>
          </p:cNvPr>
          <p:cNvSpPr txBox="1"/>
          <p:nvPr/>
        </p:nvSpPr>
        <p:spPr>
          <a:xfrm>
            <a:off x="-109182" y="2275996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B5508F1-4E42-F4E4-9A7B-C84562609D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2570" y="691726"/>
            <a:ext cx="2171700" cy="150114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AF2FFA7-654E-5640-C1BE-7A3B8A3E9F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6113" y="690070"/>
            <a:ext cx="2171700" cy="150114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B28E893-EFE9-BE85-AB50-82E6F910C7E8}"/>
              </a:ext>
            </a:extLst>
          </p:cNvPr>
          <p:cNvSpPr txBox="1"/>
          <p:nvPr/>
        </p:nvSpPr>
        <p:spPr>
          <a:xfrm>
            <a:off x="211356" y="434818"/>
            <a:ext cx="59255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E" sz="1200" i="1" dirty="0" err="1">
                <a:latin typeface="Arial" panose="020B0604020202020204" pitchFamily="34" charset="0"/>
              </a:rPr>
              <a:t>i</a:t>
            </a:r>
            <a:endParaRPr lang="en-IE" sz="1200" i="1" dirty="0">
              <a:effectLst/>
              <a:latin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BAE35CC-8DDD-3070-84F8-D6EEAB1FE318}"/>
              </a:ext>
            </a:extLst>
          </p:cNvPr>
          <p:cNvSpPr txBox="1"/>
          <p:nvPr/>
        </p:nvSpPr>
        <p:spPr>
          <a:xfrm>
            <a:off x="293660" y="212450"/>
            <a:ext cx="31251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E" sz="1200" b="1" i="1" dirty="0">
                <a:effectLst/>
                <a:latin typeface="Arial" panose="020B0604020202020204" pitchFamily="34" charset="0"/>
              </a:rPr>
              <a:t>A</a:t>
            </a:r>
            <a:endParaRPr lang="en-IE" sz="1200" b="1" dirty="0">
              <a:effectLst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9BB0B268-12EF-B254-7DF4-275C64609D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8561" y="2503019"/>
            <a:ext cx="2171700" cy="150114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FD1CC93-B3DA-99A1-6140-914245672D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12570" y="2503019"/>
            <a:ext cx="2171700" cy="150114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F89784B-66E8-3284-499F-0F06A2B3A1C8}"/>
              </a:ext>
            </a:extLst>
          </p:cNvPr>
          <p:cNvSpPr txBox="1"/>
          <p:nvPr/>
        </p:nvSpPr>
        <p:spPr>
          <a:xfrm>
            <a:off x="1092319" y="3496998"/>
            <a:ext cx="2856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nm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C0A4C05-3F10-AAD7-093E-903ABA22C791}"/>
              </a:ext>
            </a:extLst>
          </p:cNvPr>
          <p:cNvSpPr txBox="1"/>
          <p:nvPr/>
        </p:nvSpPr>
        <p:spPr>
          <a:xfrm>
            <a:off x="3375563" y="3496998"/>
            <a:ext cx="2856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n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A24DAAA-7F76-C670-CDA4-C1A3E8459766}"/>
              </a:ext>
            </a:extLst>
          </p:cNvPr>
          <p:cNvSpPr txBox="1"/>
          <p:nvPr/>
        </p:nvSpPr>
        <p:spPr>
          <a:xfrm>
            <a:off x="128384" y="4204040"/>
            <a:ext cx="74244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4:</a:t>
            </a:r>
            <a:r>
              <a:rPr lang="en-IE" sz="1000" b="1" i="1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C50 analysis for TG and COTI-2 in CAL-51 and MDA-MB-157 cells. </a:t>
            </a:r>
            <a:r>
              <a:rPr lang="en-IE" sz="1000" i="1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IE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IE" sz="1000" i="1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IC50 determination for thapsigargin (TG) in (</a:t>
            </a:r>
            <a:r>
              <a:rPr lang="en-IE" sz="1000" i="1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lang="en-IE" sz="1000" i="1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CAL-51 and (ii) MDA-MB-157 cells. Dose-response curves illustrate the inhibitory effect of TG on cell growth, with calculated IC50 values for each cell line. (B) IC50 determination for COTI-2 in (</a:t>
            </a:r>
            <a:r>
              <a:rPr lang="en-IE" sz="1000" i="1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lang="en-IE" sz="1000" i="1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CAL-51 and (ii) MDA-MB-157 cells. Dose-response curves display the inhibitory effect of COTI-2 on cell proliferation, highlighting differences in sensitivity between the two cell lines.</a:t>
            </a:r>
            <a:endParaRPr lang="en-IE" sz="1000" i="1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4FD8C9A-F8F5-7CDA-E417-56089B8FB649}"/>
              </a:ext>
            </a:extLst>
          </p:cNvPr>
          <p:cNvSpPr txBox="1"/>
          <p:nvPr/>
        </p:nvSpPr>
        <p:spPr>
          <a:xfrm>
            <a:off x="2498185" y="442043"/>
            <a:ext cx="59255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E" sz="1200" i="1" dirty="0">
                <a:latin typeface="Arial" panose="020B0604020202020204" pitchFamily="34" charset="0"/>
              </a:rPr>
              <a:t>ii</a:t>
            </a:r>
            <a:endParaRPr lang="en-IE" sz="1200" i="1" dirty="0">
              <a:effectLst/>
              <a:latin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4C13A45-7F5D-D752-4404-6D1D95D64DAE}"/>
              </a:ext>
            </a:extLst>
          </p:cNvPr>
          <p:cNvSpPr txBox="1"/>
          <p:nvPr/>
        </p:nvSpPr>
        <p:spPr>
          <a:xfrm>
            <a:off x="208723" y="2310470"/>
            <a:ext cx="59255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E" sz="1200" i="1" dirty="0" err="1">
                <a:latin typeface="Arial" panose="020B0604020202020204" pitchFamily="34" charset="0"/>
              </a:rPr>
              <a:t>i</a:t>
            </a:r>
            <a:endParaRPr lang="en-IE" sz="1200" i="1" dirty="0">
              <a:effectLst/>
              <a:latin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AF9E9CD-E459-A9BF-BE21-FA2C6BEA5C8A}"/>
              </a:ext>
            </a:extLst>
          </p:cNvPr>
          <p:cNvSpPr txBox="1"/>
          <p:nvPr/>
        </p:nvSpPr>
        <p:spPr>
          <a:xfrm>
            <a:off x="2495552" y="2317695"/>
            <a:ext cx="59255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E" sz="1200" i="1" dirty="0">
                <a:latin typeface="Arial" panose="020B0604020202020204" pitchFamily="34" charset="0"/>
              </a:rPr>
              <a:t>ii</a:t>
            </a:r>
            <a:endParaRPr lang="en-IE" sz="1200" i="1" dirty="0">
              <a:effectLst/>
              <a:latin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C2C380B-2F85-2D41-7C59-583F3B66D4CB}"/>
              </a:ext>
            </a:extLst>
          </p:cNvPr>
          <p:cNvSpPr txBox="1"/>
          <p:nvPr/>
        </p:nvSpPr>
        <p:spPr>
          <a:xfrm>
            <a:off x="193112" y="2172887"/>
            <a:ext cx="31251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IE" sz="1200" b="1" i="1" dirty="0">
                <a:effectLst/>
                <a:latin typeface="Arial" panose="020B0604020202020204" pitchFamily="34" charset="0"/>
              </a:rPr>
              <a:t>B</a:t>
            </a:r>
            <a:endParaRPr lang="en-IE" sz="1200" b="1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667765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8</TotalTime>
  <Words>420</Words>
  <Application>Microsoft Macintosh PowerPoint</Application>
  <PresentationFormat>Widescreen</PresentationFormat>
  <Paragraphs>38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Buchanan</dc:creator>
  <cp:lastModifiedBy>Paul Buchanan</cp:lastModifiedBy>
  <cp:revision>8</cp:revision>
  <dcterms:created xsi:type="dcterms:W3CDTF">2025-04-28T12:50:24Z</dcterms:created>
  <dcterms:modified xsi:type="dcterms:W3CDTF">2025-05-08T20:05:04Z</dcterms:modified>
</cp:coreProperties>
</file>